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680" r:id="rId2"/>
  </p:sldIdLst>
  <p:sldSz cx="7772400" cy="12192000"/>
  <p:notesSz cx="6858000" cy="9144000"/>
  <p:defaultTextStyle>
    <a:defPPr>
      <a:defRPr lang="x-non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774"/>
    <p:restoredTop sz="94605"/>
  </p:normalViewPr>
  <p:slideViewPr>
    <p:cSldViewPr snapToGrid="0" snapToObjects="1">
      <p:cViewPr varScale="1">
        <p:scale>
          <a:sx n="60" d="100"/>
          <a:sy n="60" d="100"/>
        </p:scale>
        <p:origin x="28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avidkwasi/Desktop/PhD/Phd-These%20files-2021/Journal/NTD%20journal/Summary%20of%20graphs-PNTD%20journal.xls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avidkwasi/Desktop/PhD/Phd-These%20files-2021/Journal/NTD%20journal/Summary%20of%20graphs-PNTD%20journal.xls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davidkwasi/Desktop/PhD/Phd-These%20files-2021/Journal/NTD%20journal/Summary%20of%20graphs-PNTD%20journal.xls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678165336831502"/>
          <c:y val="0.13315926892950392"/>
          <c:w val="0.65195463008888077"/>
          <c:h val="0.7230803231841449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Aur-conc dep'!$B$4</c:f>
              <c:strCache>
                <c:ptCount val="1"/>
                <c:pt idx="0">
                  <c:v>No drug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r-conc dep'!$K$4:$P$4</c:f>
                <c:numCache>
                  <c:formatCode>General</c:formatCode>
                  <c:ptCount val="6"/>
                  <c:pt idx="0">
                    <c:v>5.1733290377989245E-2</c:v>
                  </c:pt>
                  <c:pt idx="1">
                    <c:v>6.027713773342297E-2</c:v>
                  </c:pt>
                  <c:pt idx="2">
                    <c:v>6.0210741012986423E-2</c:v>
                  </c:pt>
                  <c:pt idx="3">
                    <c:v>1.4571661996262884E-2</c:v>
                  </c:pt>
                  <c:pt idx="4">
                    <c:v>9.0066641993574878E-2</c:v>
                  </c:pt>
                  <c:pt idx="5">
                    <c:v>8.491368166163793E-2</c:v>
                  </c:pt>
                </c:numCache>
              </c:numRef>
            </c:plus>
            <c:minus>
              <c:numRef>
                <c:f>'Aur-conc dep'!$K$4:$P$4</c:f>
                <c:numCache>
                  <c:formatCode>General</c:formatCode>
                  <c:ptCount val="6"/>
                  <c:pt idx="0">
                    <c:v>5.1733290377989245E-2</c:v>
                  </c:pt>
                  <c:pt idx="1">
                    <c:v>6.027713773342297E-2</c:v>
                  </c:pt>
                  <c:pt idx="2">
                    <c:v>6.0210741012986423E-2</c:v>
                  </c:pt>
                  <c:pt idx="3">
                    <c:v>1.4571661996262884E-2</c:v>
                  </c:pt>
                  <c:pt idx="4">
                    <c:v>9.0066641993574878E-2</c:v>
                  </c:pt>
                  <c:pt idx="5">
                    <c:v>8.4913681661637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ur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Aur-conc dep'!$C$4:$H$4</c:f>
              <c:numCache>
                <c:formatCode>0.000</c:formatCode>
                <c:ptCount val="6"/>
                <c:pt idx="0">
                  <c:v>0.83750000000000002</c:v>
                </c:pt>
                <c:pt idx="1">
                  <c:v>1.7913333333333332</c:v>
                </c:pt>
                <c:pt idx="2">
                  <c:v>1.7206666666666666</c:v>
                </c:pt>
                <c:pt idx="3">
                  <c:v>1.0313333333333332</c:v>
                </c:pt>
                <c:pt idx="4">
                  <c:v>2.41</c:v>
                </c:pt>
                <c:pt idx="5">
                  <c:v>1.5986666666666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12F-3F45-9E6B-3B7840DF2711}"/>
            </c:ext>
          </c:extLst>
        </c:ser>
        <c:ser>
          <c:idx val="1"/>
          <c:order val="1"/>
          <c:tx>
            <c:strRef>
              <c:f>'Aur-conc dep'!$B$5</c:f>
              <c:strCache>
                <c:ptCount val="1"/>
                <c:pt idx="0">
                  <c:v>0.313µ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r-conc dep'!$K$5:$P$5</c:f>
                <c:numCache>
                  <c:formatCode>General</c:formatCode>
                  <c:ptCount val="6"/>
                  <c:pt idx="0">
                    <c:v>3.4588051886935679E-2</c:v>
                  </c:pt>
                  <c:pt idx="1">
                    <c:v>3.111269837220812E-2</c:v>
                  </c:pt>
                  <c:pt idx="2">
                    <c:v>0.1329360748630681</c:v>
                  </c:pt>
                  <c:pt idx="3">
                    <c:v>7.3384830403384976E-2</c:v>
                  </c:pt>
                  <c:pt idx="4">
                    <c:v>9.2115869063553207E-2</c:v>
                  </c:pt>
                  <c:pt idx="5">
                    <c:v>1.2727922061357866E-2</c:v>
                  </c:pt>
                </c:numCache>
              </c:numRef>
            </c:plus>
            <c:minus>
              <c:numRef>
                <c:f>'Aur-conc dep'!$K$5:$P$5</c:f>
                <c:numCache>
                  <c:formatCode>General</c:formatCode>
                  <c:ptCount val="6"/>
                  <c:pt idx="0">
                    <c:v>3.4588051886935679E-2</c:v>
                  </c:pt>
                  <c:pt idx="1">
                    <c:v>3.111269837220812E-2</c:v>
                  </c:pt>
                  <c:pt idx="2">
                    <c:v>0.1329360748630681</c:v>
                  </c:pt>
                  <c:pt idx="3">
                    <c:v>7.3384830403384976E-2</c:v>
                  </c:pt>
                  <c:pt idx="4">
                    <c:v>9.2115869063553207E-2</c:v>
                  </c:pt>
                  <c:pt idx="5">
                    <c:v>1.27279220613578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ur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Aur-conc dep'!$C$5:$H$5</c:f>
              <c:numCache>
                <c:formatCode>0.000</c:formatCode>
                <c:ptCount val="6"/>
                <c:pt idx="0">
                  <c:v>0.51333333333333331</c:v>
                </c:pt>
                <c:pt idx="1">
                  <c:v>1.1719999999999999</c:v>
                </c:pt>
                <c:pt idx="2">
                  <c:v>1.3140000000000001</c:v>
                </c:pt>
                <c:pt idx="3">
                  <c:v>0.84666666666666668</c:v>
                </c:pt>
                <c:pt idx="4">
                  <c:v>1.2453333333333332</c:v>
                </c:pt>
                <c:pt idx="5">
                  <c:v>0.842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12F-3F45-9E6B-3B7840DF2711}"/>
            </c:ext>
          </c:extLst>
        </c:ser>
        <c:ser>
          <c:idx val="2"/>
          <c:order val="2"/>
          <c:tx>
            <c:strRef>
              <c:f>'Aur-conc dep'!$B$6</c:f>
              <c:strCache>
                <c:ptCount val="1"/>
                <c:pt idx="0">
                  <c:v>0.625µ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r-conc dep'!$K$6:$P$6</c:f>
                <c:numCache>
                  <c:formatCode>General</c:formatCode>
                  <c:ptCount val="6"/>
                  <c:pt idx="0">
                    <c:v>6.1294371682887899E-2</c:v>
                  </c:pt>
                  <c:pt idx="1">
                    <c:v>6.931089380465405E-2</c:v>
                  </c:pt>
                  <c:pt idx="2">
                    <c:v>5.798275605730531E-2</c:v>
                  </c:pt>
                  <c:pt idx="3">
                    <c:v>3.8890872965254758E-2</c:v>
                  </c:pt>
                  <c:pt idx="4">
                    <c:v>0.12515790027001791</c:v>
                  </c:pt>
                  <c:pt idx="5">
                    <c:v>9.2630988335434677E-2</c:v>
                  </c:pt>
                </c:numCache>
              </c:numRef>
            </c:plus>
            <c:minus>
              <c:numRef>
                <c:f>'Aur-conc dep'!$K$6:$P$6</c:f>
                <c:numCache>
                  <c:formatCode>General</c:formatCode>
                  <c:ptCount val="6"/>
                  <c:pt idx="0">
                    <c:v>6.1294371682887899E-2</c:v>
                  </c:pt>
                  <c:pt idx="1">
                    <c:v>6.931089380465405E-2</c:v>
                  </c:pt>
                  <c:pt idx="2">
                    <c:v>5.798275605730531E-2</c:v>
                  </c:pt>
                  <c:pt idx="3">
                    <c:v>3.8890872965254758E-2</c:v>
                  </c:pt>
                  <c:pt idx="4">
                    <c:v>0.12515790027001791</c:v>
                  </c:pt>
                  <c:pt idx="5">
                    <c:v>9.26309883354346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ur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Aur-conc dep'!$C$6:$H$6</c:f>
              <c:numCache>
                <c:formatCode>0.000</c:formatCode>
                <c:ptCount val="6"/>
                <c:pt idx="0">
                  <c:v>0.51900000000000002</c:v>
                </c:pt>
                <c:pt idx="1">
                  <c:v>1.224</c:v>
                </c:pt>
                <c:pt idx="2">
                  <c:v>1.5409999999999999</c:v>
                </c:pt>
                <c:pt idx="3">
                  <c:v>0.88850000000000007</c:v>
                </c:pt>
                <c:pt idx="4">
                  <c:v>1.9185000000000001</c:v>
                </c:pt>
                <c:pt idx="5">
                  <c:v>1.182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412F-3F45-9E6B-3B7840DF2711}"/>
            </c:ext>
          </c:extLst>
        </c:ser>
        <c:ser>
          <c:idx val="3"/>
          <c:order val="3"/>
          <c:tx>
            <c:strRef>
              <c:f>'Aur-conc dep'!$B$7</c:f>
              <c:strCache>
                <c:ptCount val="1"/>
                <c:pt idx="0">
                  <c:v>1.25µ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r-conc dep'!$K$6:$P$6</c:f>
                <c:numCache>
                  <c:formatCode>General</c:formatCode>
                  <c:ptCount val="6"/>
                  <c:pt idx="0">
                    <c:v>6.1294371682887899E-2</c:v>
                  </c:pt>
                  <c:pt idx="1">
                    <c:v>6.931089380465405E-2</c:v>
                  </c:pt>
                  <c:pt idx="2">
                    <c:v>5.798275605730531E-2</c:v>
                  </c:pt>
                  <c:pt idx="3">
                    <c:v>3.8890872965254758E-2</c:v>
                  </c:pt>
                  <c:pt idx="4">
                    <c:v>0.12515790027001791</c:v>
                  </c:pt>
                  <c:pt idx="5">
                    <c:v>9.2630988335434677E-2</c:v>
                  </c:pt>
                </c:numCache>
              </c:numRef>
            </c:plus>
            <c:minus>
              <c:numRef>
                <c:f>'Aur-conc dep'!$K$6:$P$6</c:f>
                <c:numCache>
                  <c:formatCode>General</c:formatCode>
                  <c:ptCount val="6"/>
                  <c:pt idx="0">
                    <c:v>6.1294371682887899E-2</c:v>
                  </c:pt>
                  <c:pt idx="1">
                    <c:v>6.931089380465405E-2</c:v>
                  </c:pt>
                  <c:pt idx="2">
                    <c:v>5.798275605730531E-2</c:v>
                  </c:pt>
                  <c:pt idx="3">
                    <c:v>3.8890872965254758E-2</c:v>
                  </c:pt>
                  <c:pt idx="4">
                    <c:v>0.12515790027001791</c:v>
                  </c:pt>
                  <c:pt idx="5">
                    <c:v>9.263098833543467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ur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Aur-conc dep'!$C$7:$H$7</c:f>
              <c:numCache>
                <c:formatCode>0.000</c:formatCode>
                <c:ptCount val="6"/>
                <c:pt idx="0">
                  <c:v>0.442</c:v>
                </c:pt>
                <c:pt idx="1">
                  <c:v>1.1233333333333333</c:v>
                </c:pt>
                <c:pt idx="2">
                  <c:v>1.2829999999999999</c:v>
                </c:pt>
                <c:pt idx="3">
                  <c:v>0.95233333333333337</c:v>
                </c:pt>
                <c:pt idx="4">
                  <c:v>1.1066666666666667</c:v>
                </c:pt>
                <c:pt idx="5">
                  <c:v>1.213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412F-3F45-9E6B-3B7840DF2711}"/>
            </c:ext>
          </c:extLst>
        </c:ser>
        <c:ser>
          <c:idx val="4"/>
          <c:order val="4"/>
          <c:tx>
            <c:strRef>
              <c:f>'Aur-conc dep'!$B$8</c:f>
              <c:strCache>
                <c:ptCount val="1"/>
                <c:pt idx="0">
                  <c:v>2.5µ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r-conc dep'!$K$8:$P$8</c:f>
                <c:numCache>
                  <c:formatCode>General</c:formatCode>
                  <c:ptCount val="6"/>
                  <c:pt idx="0">
                    <c:v>3.2578111260988696E-2</c:v>
                  </c:pt>
                  <c:pt idx="1">
                    <c:v>7.7781745930520937E-2</c:v>
                  </c:pt>
                  <c:pt idx="2">
                    <c:v>4.8083261120683875E-2</c:v>
                  </c:pt>
                  <c:pt idx="3">
                    <c:v>3.897435053981077E-2</c:v>
                  </c:pt>
                  <c:pt idx="4">
                    <c:v>7.6072333998640093E-2</c:v>
                  </c:pt>
                  <c:pt idx="5">
                    <c:v>0.13152186130069543</c:v>
                  </c:pt>
                </c:numCache>
              </c:numRef>
            </c:plus>
            <c:minus>
              <c:numRef>
                <c:f>'Aur-conc dep'!$K$8:$P$8</c:f>
                <c:numCache>
                  <c:formatCode>General</c:formatCode>
                  <c:ptCount val="6"/>
                  <c:pt idx="0">
                    <c:v>3.2578111260988696E-2</c:v>
                  </c:pt>
                  <c:pt idx="1">
                    <c:v>7.7781745930520937E-2</c:v>
                  </c:pt>
                  <c:pt idx="2">
                    <c:v>4.8083261120683875E-2</c:v>
                  </c:pt>
                  <c:pt idx="3">
                    <c:v>3.897435053981077E-2</c:v>
                  </c:pt>
                  <c:pt idx="4">
                    <c:v>7.6072333998640093E-2</c:v>
                  </c:pt>
                  <c:pt idx="5">
                    <c:v>0.131521861300695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ur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Aur-conc dep'!$C$8:$H$8</c:f>
              <c:numCache>
                <c:formatCode>0.000</c:formatCode>
                <c:ptCount val="6"/>
                <c:pt idx="0">
                  <c:v>0.37833333333333335</c:v>
                </c:pt>
                <c:pt idx="1">
                  <c:v>1.097</c:v>
                </c:pt>
                <c:pt idx="2">
                  <c:v>1.448</c:v>
                </c:pt>
                <c:pt idx="3">
                  <c:v>0.875</c:v>
                </c:pt>
                <c:pt idx="4">
                  <c:v>1.764</c:v>
                </c:pt>
                <c:pt idx="5">
                  <c:v>1.378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412F-3F45-9E6B-3B7840DF2711}"/>
            </c:ext>
          </c:extLst>
        </c:ser>
        <c:ser>
          <c:idx val="5"/>
          <c:order val="5"/>
          <c:tx>
            <c:strRef>
              <c:f>'Aur-conc dep'!$B$9</c:f>
              <c:strCache>
                <c:ptCount val="1"/>
                <c:pt idx="0">
                  <c:v>5µ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r-conc dep'!$K$9:$P$9</c:f>
                <c:numCache>
                  <c:formatCode>General</c:formatCode>
                  <c:ptCount val="6"/>
                  <c:pt idx="0">
                    <c:v>6.066575090883957E-2</c:v>
                  </c:pt>
                  <c:pt idx="1">
                    <c:v>1.4142135623730963E-2</c:v>
                  </c:pt>
                  <c:pt idx="2">
                    <c:v>0.1145512985522191</c:v>
                  </c:pt>
                  <c:pt idx="3">
                    <c:v>4.7570999569061842E-2</c:v>
                  </c:pt>
                  <c:pt idx="4">
                    <c:v>9.4572723340297787E-2</c:v>
                  </c:pt>
                  <c:pt idx="5">
                    <c:v>2.5455844122715732E-2</c:v>
                  </c:pt>
                </c:numCache>
              </c:numRef>
            </c:plus>
            <c:minus>
              <c:numRef>
                <c:f>'Aur-conc dep'!$K$9:$P$9</c:f>
                <c:numCache>
                  <c:formatCode>General</c:formatCode>
                  <c:ptCount val="6"/>
                  <c:pt idx="0">
                    <c:v>6.066575090883957E-2</c:v>
                  </c:pt>
                  <c:pt idx="1">
                    <c:v>1.4142135623730963E-2</c:v>
                  </c:pt>
                  <c:pt idx="2">
                    <c:v>0.1145512985522191</c:v>
                  </c:pt>
                  <c:pt idx="3">
                    <c:v>4.7570999569061842E-2</c:v>
                  </c:pt>
                  <c:pt idx="4">
                    <c:v>9.4572723340297787E-2</c:v>
                  </c:pt>
                  <c:pt idx="5">
                    <c:v>2.545584412271573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ur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Aur-conc dep'!$C$9:$H$9</c:f>
              <c:numCache>
                <c:formatCode>0.000</c:formatCode>
                <c:ptCount val="6"/>
                <c:pt idx="0">
                  <c:v>0.37633333333333335</c:v>
                </c:pt>
                <c:pt idx="1">
                  <c:v>1.042</c:v>
                </c:pt>
                <c:pt idx="2">
                  <c:v>1.2850000000000001</c:v>
                </c:pt>
                <c:pt idx="3">
                  <c:v>0.79100000000000004</c:v>
                </c:pt>
                <c:pt idx="4">
                  <c:v>1.232</c:v>
                </c:pt>
                <c:pt idx="5">
                  <c:v>1.41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412F-3F45-9E6B-3B7840DF2711}"/>
            </c:ext>
          </c:extLst>
        </c:ser>
        <c:ser>
          <c:idx val="6"/>
          <c:order val="6"/>
          <c:tx>
            <c:strRef>
              <c:f>'Aur-conc dep'!$B$10</c:f>
              <c:strCache>
                <c:ptCount val="1"/>
                <c:pt idx="0">
                  <c:v>10µ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r-conc dep'!$K$10:$P$10</c:f>
                <c:numCache>
                  <c:formatCode>General</c:formatCode>
                  <c:ptCount val="6"/>
                  <c:pt idx="0">
                    <c:v>9.4516312525052253E-3</c:v>
                  </c:pt>
                  <c:pt idx="1">
                    <c:v>7.7597250810407012E-2</c:v>
                  </c:pt>
                  <c:pt idx="2">
                    <c:v>9.9324384384370995E-2</c:v>
                  </c:pt>
                  <c:pt idx="3">
                    <c:v>3.8314488121333458E-2</c:v>
                  </c:pt>
                  <c:pt idx="4">
                    <c:v>3.4770677301427258E-2</c:v>
                  </c:pt>
                  <c:pt idx="5">
                    <c:v>8.6234177292609196E-2</c:v>
                  </c:pt>
                </c:numCache>
              </c:numRef>
            </c:plus>
            <c:minus>
              <c:numRef>
                <c:f>'Aur-conc dep'!$K$10:$P$10</c:f>
                <c:numCache>
                  <c:formatCode>General</c:formatCode>
                  <c:ptCount val="6"/>
                  <c:pt idx="0">
                    <c:v>9.4516312525052253E-3</c:v>
                  </c:pt>
                  <c:pt idx="1">
                    <c:v>7.7597250810407012E-2</c:v>
                  </c:pt>
                  <c:pt idx="2">
                    <c:v>9.9324384384370995E-2</c:v>
                  </c:pt>
                  <c:pt idx="3">
                    <c:v>3.8314488121333458E-2</c:v>
                  </c:pt>
                  <c:pt idx="4">
                    <c:v>3.4770677301427258E-2</c:v>
                  </c:pt>
                  <c:pt idx="5">
                    <c:v>8.623417729260919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ur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Aur-conc dep'!$C$10:$H$10</c:f>
              <c:numCache>
                <c:formatCode>0.000</c:formatCode>
                <c:ptCount val="6"/>
                <c:pt idx="0">
                  <c:v>0.32666666666666666</c:v>
                </c:pt>
                <c:pt idx="1">
                  <c:v>1.1426666666666667</c:v>
                </c:pt>
                <c:pt idx="2">
                  <c:v>1.3773333333333333</c:v>
                </c:pt>
                <c:pt idx="3">
                  <c:v>0.79100000000000004</c:v>
                </c:pt>
                <c:pt idx="4">
                  <c:v>1.6839999999999999</c:v>
                </c:pt>
                <c:pt idx="5">
                  <c:v>0.9936666666666665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412F-3F45-9E6B-3B7840DF2711}"/>
            </c:ext>
          </c:extLst>
        </c:ser>
        <c:ser>
          <c:idx val="7"/>
          <c:order val="7"/>
          <c:tx>
            <c:strRef>
              <c:f>'Aur-conc dep'!$B$11</c:f>
              <c:strCache>
                <c:ptCount val="1"/>
                <c:pt idx="0">
                  <c:v>20µ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Aur-conc dep'!$K$11:$P$11</c:f>
                <c:numCache>
                  <c:formatCode>General</c:formatCode>
                  <c:ptCount val="6"/>
                  <c:pt idx="0">
                    <c:v>1.4730919862656216E-2</c:v>
                  </c:pt>
                  <c:pt idx="1">
                    <c:v>0.13293607486307144</c:v>
                  </c:pt>
                  <c:pt idx="2">
                    <c:v>6.0811183182039263E-2</c:v>
                  </c:pt>
                  <c:pt idx="3">
                    <c:v>7.4343795975186602E-2</c:v>
                  </c:pt>
                  <c:pt idx="4">
                    <c:v>9.1847700025643284E-2</c:v>
                  </c:pt>
                  <c:pt idx="5">
                    <c:v>9.2630988335438272E-2</c:v>
                  </c:pt>
                </c:numCache>
              </c:numRef>
            </c:plus>
            <c:minus>
              <c:numRef>
                <c:f>'Aur-conc dep'!$K$11:$P$11</c:f>
                <c:numCache>
                  <c:formatCode>General</c:formatCode>
                  <c:ptCount val="6"/>
                  <c:pt idx="0">
                    <c:v>1.4730919862656216E-2</c:v>
                  </c:pt>
                  <c:pt idx="1">
                    <c:v>0.13293607486307144</c:v>
                  </c:pt>
                  <c:pt idx="2">
                    <c:v>6.0811183182039263E-2</c:v>
                  </c:pt>
                  <c:pt idx="3">
                    <c:v>7.4343795975186602E-2</c:v>
                  </c:pt>
                  <c:pt idx="4">
                    <c:v>9.1847700025643284E-2</c:v>
                  </c:pt>
                  <c:pt idx="5">
                    <c:v>9.26309883354382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Aur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Aur-conc dep'!$C$11:$H$11</c:f>
              <c:numCache>
                <c:formatCode>0.000</c:formatCode>
                <c:ptCount val="6"/>
                <c:pt idx="0">
                  <c:v>0.28699999999999998</c:v>
                </c:pt>
                <c:pt idx="1">
                  <c:v>0.90200000000000002</c:v>
                </c:pt>
                <c:pt idx="2">
                  <c:v>1.2930000000000001</c:v>
                </c:pt>
                <c:pt idx="3">
                  <c:v>0.68299999999999994</c:v>
                </c:pt>
                <c:pt idx="4">
                  <c:v>1.43</c:v>
                </c:pt>
                <c:pt idx="5">
                  <c:v>0.9014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412F-3F45-9E6B-3B7840DF27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93352816"/>
        <c:axId val="1793710304"/>
      </c:scatterChart>
      <c:valAx>
        <c:axId val="17933528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200" b="1" i="0" baseline="0">
                    <a:effectLst/>
                  </a:rPr>
                  <a:t>Time (hs)</a:t>
                </a:r>
                <a:endParaRPr lang="en-NG" sz="12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3710304"/>
        <c:crosses val="autoZero"/>
        <c:crossBetween val="midCat"/>
      </c:valAx>
      <c:valAx>
        <c:axId val="17937103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200" b="1" i="0" baseline="0">
                    <a:effectLst/>
                  </a:rPr>
                  <a:t>Absorbance of eluted crystal violet at 570nm (biofilms) </a:t>
                </a:r>
                <a:endParaRPr lang="en-NG" sz="1200">
                  <a:effectLst/>
                </a:endParaRPr>
              </a:p>
            </c:rich>
          </c:tx>
          <c:layout>
            <c:manualLayout>
              <c:xMode val="edge"/>
              <c:yMode val="edge"/>
              <c:x val="1.630021141649049E-2"/>
              <c:y val="0.127572691681696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335281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1031434184675832"/>
          <c:y val="0.1204432474661294"/>
          <c:w val="0.18487229862475446"/>
          <c:h val="0.432957594686139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47851436221344"/>
          <c:y val="0.1829258184832159"/>
          <c:w val="0.63640163621789148"/>
          <c:h val="0.6744728309890056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Clof-conc dep'!$B$4</c:f>
              <c:strCache>
                <c:ptCount val="1"/>
                <c:pt idx="0">
                  <c:v>No drug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lof-conc dep'!$J$4:$O$4</c:f>
                <c:numCache>
                  <c:formatCode>General</c:formatCode>
                  <c:ptCount val="6"/>
                  <c:pt idx="0">
                    <c:v>5.1733290377989245E-2</c:v>
                  </c:pt>
                  <c:pt idx="1">
                    <c:v>6.027713773342297E-2</c:v>
                  </c:pt>
                  <c:pt idx="2">
                    <c:v>6.0210741012986423E-2</c:v>
                  </c:pt>
                  <c:pt idx="3">
                    <c:v>1.4571661996262884E-2</c:v>
                  </c:pt>
                  <c:pt idx="4">
                    <c:v>9.0066641993574878E-2</c:v>
                  </c:pt>
                  <c:pt idx="5">
                    <c:v>8.491368166163793E-2</c:v>
                  </c:pt>
                </c:numCache>
              </c:numRef>
            </c:plus>
            <c:minus>
              <c:numRef>
                <c:f>'Clof-conc dep'!$J$4:$O$4</c:f>
                <c:numCache>
                  <c:formatCode>General</c:formatCode>
                  <c:ptCount val="6"/>
                  <c:pt idx="0">
                    <c:v>5.1733290377989245E-2</c:v>
                  </c:pt>
                  <c:pt idx="1">
                    <c:v>6.027713773342297E-2</c:v>
                  </c:pt>
                  <c:pt idx="2">
                    <c:v>6.0210741012986423E-2</c:v>
                  </c:pt>
                  <c:pt idx="3">
                    <c:v>1.4571661996262884E-2</c:v>
                  </c:pt>
                  <c:pt idx="4">
                    <c:v>9.0066641993574878E-2</c:v>
                  </c:pt>
                  <c:pt idx="5">
                    <c:v>8.4913681661637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lof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Clof-conc dep'!$C$4:$H$4</c:f>
              <c:numCache>
                <c:formatCode>0.000</c:formatCode>
                <c:ptCount val="6"/>
                <c:pt idx="0">
                  <c:v>0.83750000000000002</c:v>
                </c:pt>
                <c:pt idx="1">
                  <c:v>1.7913333333333332</c:v>
                </c:pt>
                <c:pt idx="2">
                  <c:v>1.7206666666666666</c:v>
                </c:pt>
                <c:pt idx="3">
                  <c:v>1.0313333333333332</c:v>
                </c:pt>
                <c:pt idx="4">
                  <c:v>2.41</c:v>
                </c:pt>
                <c:pt idx="5">
                  <c:v>1.5986666666666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FD9F-C649-A14C-E9695798D855}"/>
            </c:ext>
          </c:extLst>
        </c:ser>
        <c:ser>
          <c:idx val="1"/>
          <c:order val="1"/>
          <c:tx>
            <c:strRef>
              <c:f>'Clof-conc dep'!$B$5</c:f>
              <c:strCache>
                <c:ptCount val="1"/>
                <c:pt idx="0">
                  <c:v>0.313µ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lof-conc dep'!$J$5:$O$5</c:f>
                <c:numCache>
                  <c:formatCode>General</c:formatCode>
                  <c:ptCount val="6"/>
                  <c:pt idx="0">
                    <c:v>3.897435053981077E-2</c:v>
                  </c:pt>
                  <c:pt idx="1">
                    <c:v>7.7571472419521934E-2</c:v>
                  </c:pt>
                  <c:pt idx="2">
                    <c:v>1.4142135623730963E-3</c:v>
                  </c:pt>
                  <c:pt idx="3">
                    <c:v>3.80043857118278E-2</c:v>
                  </c:pt>
                  <c:pt idx="4">
                    <c:v>3.5383612025908701E-2</c:v>
                  </c:pt>
                  <c:pt idx="5">
                    <c:v>2.2627416997969541E-2</c:v>
                  </c:pt>
                </c:numCache>
              </c:numRef>
            </c:plus>
            <c:minus>
              <c:numRef>
                <c:f>'Clof-conc dep'!$J$5:$O$5</c:f>
                <c:numCache>
                  <c:formatCode>General</c:formatCode>
                  <c:ptCount val="6"/>
                  <c:pt idx="0">
                    <c:v>3.897435053981077E-2</c:v>
                  </c:pt>
                  <c:pt idx="1">
                    <c:v>7.7571472419521934E-2</c:v>
                  </c:pt>
                  <c:pt idx="2">
                    <c:v>1.4142135623730963E-3</c:v>
                  </c:pt>
                  <c:pt idx="3">
                    <c:v>3.80043857118278E-2</c:v>
                  </c:pt>
                  <c:pt idx="4">
                    <c:v>3.5383612025908701E-2</c:v>
                  </c:pt>
                  <c:pt idx="5">
                    <c:v>2.262741699796954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lof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Clof-conc dep'!$C$5:$H$5</c:f>
              <c:numCache>
                <c:formatCode>0.000</c:formatCode>
                <c:ptCount val="6"/>
                <c:pt idx="0">
                  <c:v>0.46199999999999997</c:v>
                </c:pt>
                <c:pt idx="1">
                  <c:v>1.0553333333333335</c:v>
                </c:pt>
                <c:pt idx="2">
                  <c:v>1.2509999999999999</c:v>
                </c:pt>
                <c:pt idx="3">
                  <c:v>0.93466666666666676</c:v>
                </c:pt>
                <c:pt idx="4">
                  <c:v>1.244</c:v>
                </c:pt>
                <c:pt idx="5">
                  <c:v>0.960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D9F-C649-A14C-E9695798D855}"/>
            </c:ext>
          </c:extLst>
        </c:ser>
        <c:ser>
          <c:idx val="2"/>
          <c:order val="2"/>
          <c:tx>
            <c:strRef>
              <c:f>'Clof-conc dep'!$B$6</c:f>
              <c:strCache>
                <c:ptCount val="1"/>
                <c:pt idx="0">
                  <c:v>0.625µ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lof-conc dep'!$J$6:$O$6</c:f>
                <c:numCache>
                  <c:formatCode>General</c:formatCode>
                  <c:ptCount val="6"/>
                  <c:pt idx="0">
                    <c:v>4.6669047558312575E-2</c:v>
                  </c:pt>
                  <c:pt idx="1">
                    <c:v>2.7736858750286197E-2</c:v>
                  </c:pt>
                  <c:pt idx="2">
                    <c:v>7.4953318805774855E-2</c:v>
                  </c:pt>
                  <c:pt idx="3">
                    <c:v>4.525483399593714E-2</c:v>
                  </c:pt>
                  <c:pt idx="4">
                    <c:v>1.2727922061358024E-2</c:v>
                  </c:pt>
                  <c:pt idx="5">
                    <c:v>9.4045201897810404E-2</c:v>
                  </c:pt>
                </c:numCache>
              </c:numRef>
            </c:plus>
            <c:minus>
              <c:numRef>
                <c:f>'Clof-conc dep'!$J$6:$O$6</c:f>
                <c:numCache>
                  <c:formatCode>General</c:formatCode>
                  <c:ptCount val="6"/>
                  <c:pt idx="0">
                    <c:v>4.6669047558312575E-2</c:v>
                  </c:pt>
                  <c:pt idx="1">
                    <c:v>2.7736858750286197E-2</c:v>
                  </c:pt>
                  <c:pt idx="2">
                    <c:v>7.4953318805774855E-2</c:v>
                  </c:pt>
                  <c:pt idx="3">
                    <c:v>4.525483399593714E-2</c:v>
                  </c:pt>
                  <c:pt idx="4">
                    <c:v>1.2727922061358024E-2</c:v>
                  </c:pt>
                  <c:pt idx="5">
                    <c:v>9.404520189781040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lof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Clof-conc dep'!$C$6:$H$6</c:f>
              <c:numCache>
                <c:formatCode>0.000</c:formatCode>
                <c:ptCount val="6"/>
                <c:pt idx="0">
                  <c:v>0.35</c:v>
                </c:pt>
                <c:pt idx="1">
                  <c:v>1.1446666666666667</c:v>
                </c:pt>
                <c:pt idx="2">
                  <c:v>1.4889999999999999</c:v>
                </c:pt>
                <c:pt idx="3">
                  <c:v>1.056</c:v>
                </c:pt>
                <c:pt idx="4">
                  <c:v>2.2199999999999998</c:v>
                </c:pt>
                <c:pt idx="5">
                  <c:v>1.160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FD9F-C649-A14C-E9695798D855}"/>
            </c:ext>
          </c:extLst>
        </c:ser>
        <c:ser>
          <c:idx val="3"/>
          <c:order val="3"/>
          <c:tx>
            <c:strRef>
              <c:f>'Clof-conc dep'!$B$7</c:f>
              <c:strCache>
                <c:ptCount val="1"/>
                <c:pt idx="0">
                  <c:v>1.25µ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lof-conc dep'!$J$7:$O$7</c:f>
                <c:numCache>
                  <c:formatCode>General</c:formatCode>
                  <c:ptCount val="6"/>
                  <c:pt idx="0">
                    <c:v>1.7088007490635486E-2</c:v>
                  </c:pt>
                  <c:pt idx="1">
                    <c:v>6.9060360072432797E-2</c:v>
                  </c:pt>
                  <c:pt idx="2">
                    <c:v>5.4784426010807429E-2</c:v>
                  </c:pt>
                  <c:pt idx="3">
                    <c:v>7.0021425292547998E-2</c:v>
                  </c:pt>
                  <c:pt idx="4">
                    <c:v>3.3941125496951628E-2</c:v>
                  </c:pt>
                  <c:pt idx="5">
                    <c:v>9.4752308678997005E-2</c:v>
                  </c:pt>
                </c:numCache>
              </c:numRef>
            </c:plus>
            <c:minus>
              <c:numRef>
                <c:f>'Clof-conc dep'!$J$7:$O$7</c:f>
                <c:numCache>
                  <c:formatCode>General</c:formatCode>
                  <c:ptCount val="6"/>
                  <c:pt idx="0">
                    <c:v>1.7088007490635486E-2</c:v>
                  </c:pt>
                  <c:pt idx="1">
                    <c:v>6.9060360072432797E-2</c:v>
                  </c:pt>
                  <c:pt idx="2">
                    <c:v>5.4784426010807429E-2</c:v>
                  </c:pt>
                  <c:pt idx="3">
                    <c:v>7.0021425292547998E-2</c:v>
                  </c:pt>
                  <c:pt idx="4">
                    <c:v>3.3941125496951628E-2</c:v>
                  </c:pt>
                  <c:pt idx="5">
                    <c:v>9.475230867899700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lof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Clof-conc dep'!$C$7:$H$7</c:f>
              <c:numCache>
                <c:formatCode>0.000</c:formatCode>
                <c:ptCount val="6"/>
                <c:pt idx="0">
                  <c:v>0.252</c:v>
                </c:pt>
                <c:pt idx="1">
                  <c:v>1.1086666666666665</c:v>
                </c:pt>
                <c:pt idx="2">
                  <c:v>1.5213333333333334</c:v>
                </c:pt>
                <c:pt idx="3">
                  <c:v>0.81800000000000006</c:v>
                </c:pt>
                <c:pt idx="4">
                  <c:v>1.0900000000000001</c:v>
                </c:pt>
                <c:pt idx="5">
                  <c:v>1.487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FD9F-C649-A14C-E9695798D855}"/>
            </c:ext>
          </c:extLst>
        </c:ser>
        <c:ser>
          <c:idx val="4"/>
          <c:order val="4"/>
          <c:tx>
            <c:strRef>
              <c:f>'Clof-conc dep'!$B$8</c:f>
              <c:strCache>
                <c:ptCount val="1"/>
                <c:pt idx="0">
                  <c:v>2.5µ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lof-conc dep'!$J$8:$O$8</c:f>
                <c:numCache>
                  <c:formatCode>General</c:formatCode>
                  <c:ptCount val="6"/>
                  <c:pt idx="0">
                    <c:v>1.3428824718989553E-2</c:v>
                  </c:pt>
                  <c:pt idx="1">
                    <c:v>6.8789534087679058E-2</c:v>
                  </c:pt>
                  <c:pt idx="2">
                    <c:v>5.0649119768586721E-2</c:v>
                  </c:pt>
                  <c:pt idx="3">
                    <c:v>3.494757979221589E-2</c:v>
                  </c:pt>
                  <c:pt idx="4">
                    <c:v>7.7788173908379221E-2</c:v>
                  </c:pt>
                  <c:pt idx="5">
                    <c:v>4.4547727214750629E-2</c:v>
                  </c:pt>
                </c:numCache>
              </c:numRef>
            </c:plus>
            <c:minus>
              <c:numRef>
                <c:f>'Clof-conc dep'!$J$8:$O$8</c:f>
                <c:numCache>
                  <c:formatCode>General</c:formatCode>
                  <c:ptCount val="6"/>
                  <c:pt idx="0">
                    <c:v>1.3428824718989553E-2</c:v>
                  </c:pt>
                  <c:pt idx="1">
                    <c:v>6.8789534087679058E-2</c:v>
                  </c:pt>
                  <c:pt idx="2">
                    <c:v>5.0649119768586721E-2</c:v>
                  </c:pt>
                  <c:pt idx="3">
                    <c:v>3.494757979221589E-2</c:v>
                  </c:pt>
                  <c:pt idx="4">
                    <c:v>7.7788173908379221E-2</c:v>
                  </c:pt>
                  <c:pt idx="5">
                    <c:v>4.454772721475062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lof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Clof-conc dep'!$C$8:$H$8</c:f>
              <c:numCache>
                <c:formatCode>0.000</c:formatCode>
                <c:ptCount val="6"/>
                <c:pt idx="0">
                  <c:v>0.15466666666666701</c:v>
                </c:pt>
                <c:pt idx="1">
                  <c:v>1.08</c:v>
                </c:pt>
                <c:pt idx="2">
                  <c:v>1.5733333333333335</c:v>
                </c:pt>
                <c:pt idx="3">
                  <c:v>0.85766666666666669</c:v>
                </c:pt>
                <c:pt idx="4">
                  <c:v>1.7389999999999999</c:v>
                </c:pt>
                <c:pt idx="5">
                  <c:v>1.191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FD9F-C649-A14C-E9695798D855}"/>
            </c:ext>
          </c:extLst>
        </c:ser>
        <c:ser>
          <c:idx val="5"/>
          <c:order val="5"/>
          <c:tx>
            <c:strRef>
              <c:f>'Clof-conc dep'!$B$9</c:f>
              <c:strCache>
                <c:ptCount val="1"/>
                <c:pt idx="0">
                  <c:v>5µ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lof-conc dep'!$J$9:$O$9</c:f>
                <c:numCache>
                  <c:formatCode>General</c:formatCode>
                  <c:ptCount val="6"/>
                  <c:pt idx="0">
                    <c:v>1.8175074506953975E-2</c:v>
                  </c:pt>
                  <c:pt idx="1">
                    <c:v>9.8994949366117926E-2</c:v>
                  </c:pt>
                  <c:pt idx="2">
                    <c:v>2.4041630560342638E-2</c:v>
                  </c:pt>
                  <c:pt idx="3">
                    <c:v>7.8500530783768466E-2</c:v>
                  </c:pt>
                  <c:pt idx="4">
                    <c:v>0.10454345189122725</c:v>
                  </c:pt>
                  <c:pt idx="5">
                    <c:v>0.10253048327204903</c:v>
                  </c:pt>
                </c:numCache>
              </c:numRef>
            </c:plus>
            <c:minus>
              <c:numRef>
                <c:f>'Clof-conc dep'!$J$9:$O$9</c:f>
                <c:numCache>
                  <c:formatCode>General</c:formatCode>
                  <c:ptCount val="6"/>
                  <c:pt idx="0">
                    <c:v>1.8175074506953975E-2</c:v>
                  </c:pt>
                  <c:pt idx="1">
                    <c:v>9.8994949366117926E-2</c:v>
                  </c:pt>
                  <c:pt idx="2">
                    <c:v>2.4041630560342638E-2</c:v>
                  </c:pt>
                  <c:pt idx="3">
                    <c:v>7.8500530783768466E-2</c:v>
                  </c:pt>
                  <c:pt idx="4">
                    <c:v>0.10454345189122725</c:v>
                  </c:pt>
                  <c:pt idx="5">
                    <c:v>0.102530483272049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lof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Clof-conc dep'!$C$9:$H$9</c:f>
              <c:numCache>
                <c:formatCode>0.000</c:formatCode>
                <c:ptCount val="6"/>
                <c:pt idx="0">
                  <c:v>0.16933333333333334</c:v>
                </c:pt>
                <c:pt idx="1">
                  <c:v>1.036</c:v>
                </c:pt>
                <c:pt idx="2">
                  <c:v>1.2309999999999999</c:v>
                </c:pt>
                <c:pt idx="3">
                  <c:v>0.83633333333333326</c:v>
                </c:pt>
                <c:pt idx="4">
                  <c:v>1.0766666666666667</c:v>
                </c:pt>
                <c:pt idx="5">
                  <c:v>0.807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FD9F-C649-A14C-E9695798D855}"/>
            </c:ext>
          </c:extLst>
        </c:ser>
        <c:ser>
          <c:idx val="6"/>
          <c:order val="6"/>
          <c:tx>
            <c:strRef>
              <c:f>'Clof-conc dep'!$B$10</c:f>
              <c:strCache>
                <c:ptCount val="1"/>
                <c:pt idx="0">
                  <c:v>10µ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lof-conc dep'!$J$10:$O$10</c:f>
                <c:numCache>
                  <c:formatCode>General</c:formatCode>
                  <c:ptCount val="6"/>
                  <c:pt idx="0">
                    <c:v>1.0535653752852736E-2</c:v>
                  </c:pt>
                  <c:pt idx="1">
                    <c:v>3.9715656022950442E-2</c:v>
                  </c:pt>
                  <c:pt idx="2">
                    <c:v>8.2977908706673043E-2</c:v>
                  </c:pt>
                  <c:pt idx="3">
                    <c:v>2.3259406699225986E-2</c:v>
                  </c:pt>
                  <c:pt idx="4">
                    <c:v>6.643041472097283E-2</c:v>
                  </c:pt>
                  <c:pt idx="5">
                    <c:v>4.8083261120686185E-2</c:v>
                  </c:pt>
                </c:numCache>
              </c:numRef>
            </c:plus>
            <c:minus>
              <c:numRef>
                <c:f>'Clof-conc dep'!$J$10:$O$10</c:f>
                <c:numCache>
                  <c:formatCode>General</c:formatCode>
                  <c:ptCount val="6"/>
                  <c:pt idx="0">
                    <c:v>1.0535653752852736E-2</c:v>
                  </c:pt>
                  <c:pt idx="1">
                    <c:v>3.9715656022950442E-2</c:v>
                  </c:pt>
                  <c:pt idx="2">
                    <c:v>8.2977908706673043E-2</c:v>
                  </c:pt>
                  <c:pt idx="3">
                    <c:v>2.3259406699225986E-2</c:v>
                  </c:pt>
                  <c:pt idx="4">
                    <c:v>6.643041472097283E-2</c:v>
                  </c:pt>
                  <c:pt idx="5">
                    <c:v>4.808326112068618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lof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Clof-conc dep'!$C$10:$H$10</c:f>
              <c:numCache>
                <c:formatCode>0.000</c:formatCode>
                <c:ptCount val="6"/>
                <c:pt idx="0">
                  <c:v>0.16600000000000001</c:v>
                </c:pt>
                <c:pt idx="1">
                  <c:v>0.87333333333333341</c:v>
                </c:pt>
                <c:pt idx="2">
                  <c:v>1.2006666666666665</c:v>
                </c:pt>
                <c:pt idx="3">
                  <c:v>0.80399999999999994</c:v>
                </c:pt>
                <c:pt idx="4">
                  <c:v>1.4809999999999999</c:v>
                </c:pt>
                <c:pt idx="5">
                  <c:v>0.5289999999999999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FD9F-C649-A14C-E9695798D855}"/>
            </c:ext>
          </c:extLst>
        </c:ser>
        <c:ser>
          <c:idx val="7"/>
          <c:order val="7"/>
          <c:tx>
            <c:strRef>
              <c:f>'Clof-conc dep'!$B$11</c:f>
              <c:strCache>
                <c:ptCount val="1"/>
                <c:pt idx="0">
                  <c:v>20µ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Clof-conc dep'!$C$3:$H$3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Clof-conc dep'!$C$11:$H$11</c:f>
              <c:numCache>
                <c:formatCode>0.000</c:formatCode>
                <c:ptCount val="6"/>
                <c:pt idx="0">
                  <c:v>0.19699999999999998</c:v>
                </c:pt>
                <c:pt idx="1">
                  <c:v>0.7446666666666667</c:v>
                </c:pt>
                <c:pt idx="2">
                  <c:v>1.232</c:v>
                </c:pt>
                <c:pt idx="3">
                  <c:v>0.80433333333333346</c:v>
                </c:pt>
                <c:pt idx="4">
                  <c:v>1.1459999999999999</c:v>
                </c:pt>
                <c:pt idx="5">
                  <c:v>0.4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FD9F-C649-A14C-E9695798D8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05532096"/>
        <c:axId val="1729954608"/>
      </c:scatterChart>
      <c:valAx>
        <c:axId val="18055320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200" b="1" i="0" baseline="0">
                    <a:effectLst/>
                  </a:rPr>
                  <a:t>Time (hs)</a:t>
                </a:r>
                <a:endParaRPr lang="en-NG" sz="12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29954608"/>
        <c:crosses val="autoZero"/>
        <c:crossBetween val="midCat"/>
      </c:valAx>
      <c:valAx>
        <c:axId val="17299546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200" b="1" i="0" baseline="0">
                    <a:effectLst/>
                  </a:rPr>
                  <a:t>Absorbance of eluted crystal violet at 570nm (biofilms) </a:t>
                </a:r>
                <a:endParaRPr lang="en-NG" sz="1200">
                  <a:effectLst/>
                </a:endParaRPr>
              </a:p>
            </c:rich>
          </c:tx>
          <c:layout>
            <c:manualLayout>
              <c:xMode val="edge"/>
              <c:yMode val="edge"/>
              <c:x val="2.8742138364779873E-2"/>
              <c:y val="0.143819777416091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0553209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3760312979745455"/>
          <c:y val="0.17119055997888533"/>
          <c:w val="0.15751072961373386"/>
          <c:h val="0.389933356794087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450341936810676"/>
          <c:y val="0.11352659129899265"/>
          <c:w val="0.63829090281104695"/>
          <c:h val="0.6917362424668982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Mil-conc dep'!$B$3</c:f>
              <c:strCache>
                <c:ptCount val="1"/>
                <c:pt idx="0">
                  <c:v>No drug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il-conc dep'!$J$3:$O$3</c:f>
                <c:numCache>
                  <c:formatCode>General</c:formatCode>
                  <c:ptCount val="6"/>
                  <c:pt idx="0">
                    <c:v>5.1733290377989245E-2</c:v>
                  </c:pt>
                  <c:pt idx="1">
                    <c:v>0.06</c:v>
                  </c:pt>
                  <c:pt idx="2">
                    <c:v>6.0210741012986423E-2</c:v>
                  </c:pt>
                  <c:pt idx="3">
                    <c:v>1.4571661996262884E-2</c:v>
                  </c:pt>
                  <c:pt idx="4">
                    <c:v>9.0066641993574878E-2</c:v>
                  </c:pt>
                  <c:pt idx="5">
                    <c:v>8.491368166163793E-2</c:v>
                  </c:pt>
                </c:numCache>
              </c:numRef>
            </c:plus>
            <c:minus>
              <c:numRef>
                <c:f>'Mil-conc dep'!$J$3:$O$3</c:f>
                <c:numCache>
                  <c:formatCode>General</c:formatCode>
                  <c:ptCount val="6"/>
                  <c:pt idx="0">
                    <c:v>5.1733290377989245E-2</c:v>
                  </c:pt>
                  <c:pt idx="1">
                    <c:v>0.06</c:v>
                  </c:pt>
                  <c:pt idx="2">
                    <c:v>6.0210741012986423E-2</c:v>
                  </c:pt>
                  <c:pt idx="3">
                    <c:v>1.4571661996262884E-2</c:v>
                  </c:pt>
                  <c:pt idx="4">
                    <c:v>9.0066641993574878E-2</c:v>
                  </c:pt>
                  <c:pt idx="5">
                    <c:v>8.49136816616379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il-conc dep'!$C$2:$H$2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Mil-conc dep'!$C$3:$H$3</c:f>
              <c:numCache>
                <c:formatCode>0.000</c:formatCode>
                <c:ptCount val="6"/>
                <c:pt idx="0">
                  <c:v>0.83750000000000002</c:v>
                </c:pt>
                <c:pt idx="1">
                  <c:v>1.7913333333333332</c:v>
                </c:pt>
                <c:pt idx="2">
                  <c:v>1.7206666666666666</c:v>
                </c:pt>
                <c:pt idx="3">
                  <c:v>1.0313333333333332</c:v>
                </c:pt>
                <c:pt idx="4">
                  <c:v>2.41</c:v>
                </c:pt>
                <c:pt idx="5">
                  <c:v>1.59866666666666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7C4B-654E-9EC4-094CF81F092F}"/>
            </c:ext>
          </c:extLst>
        </c:ser>
        <c:ser>
          <c:idx val="1"/>
          <c:order val="1"/>
          <c:tx>
            <c:strRef>
              <c:f>'Mil-conc dep'!$B$4</c:f>
              <c:strCache>
                <c:ptCount val="1"/>
                <c:pt idx="0">
                  <c:v>0.313µM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il-conc dep'!$J$4:$O$4</c:f>
                <c:numCache>
                  <c:formatCode>General</c:formatCode>
                  <c:ptCount val="6"/>
                  <c:pt idx="0">
                    <c:v>2.3115651263447702E-2</c:v>
                  </c:pt>
                  <c:pt idx="1">
                    <c:v>4.3588989435406879E-2</c:v>
                  </c:pt>
                  <c:pt idx="2">
                    <c:v>9.5268042910515702E-2</c:v>
                  </c:pt>
                  <c:pt idx="3">
                    <c:v>3.1069813860616143E-2</c:v>
                  </c:pt>
                  <c:pt idx="4">
                    <c:v>0.10040916292848605</c:v>
                  </c:pt>
                  <c:pt idx="5">
                    <c:v>8.4145706961200745E-2</c:v>
                  </c:pt>
                </c:numCache>
              </c:numRef>
            </c:plus>
            <c:minus>
              <c:numRef>
                <c:f>'Mil-conc dep'!$J$4:$O$4</c:f>
                <c:numCache>
                  <c:formatCode>General</c:formatCode>
                  <c:ptCount val="6"/>
                  <c:pt idx="0">
                    <c:v>2.3115651263447702E-2</c:v>
                  </c:pt>
                  <c:pt idx="1">
                    <c:v>4.3588989435406879E-2</c:v>
                  </c:pt>
                  <c:pt idx="2">
                    <c:v>9.5268042910515702E-2</c:v>
                  </c:pt>
                  <c:pt idx="3">
                    <c:v>3.1069813860616143E-2</c:v>
                  </c:pt>
                  <c:pt idx="4">
                    <c:v>0.10040916292848605</c:v>
                  </c:pt>
                  <c:pt idx="5">
                    <c:v>8.414570696120074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il-conc dep'!$C$2:$H$2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Mil-conc dep'!$C$4:$H$4</c:f>
              <c:numCache>
                <c:formatCode>0.000</c:formatCode>
                <c:ptCount val="6"/>
                <c:pt idx="0">
                  <c:v>0.58566666666666667</c:v>
                </c:pt>
                <c:pt idx="1">
                  <c:v>1.2</c:v>
                </c:pt>
                <c:pt idx="2">
                  <c:v>1.38</c:v>
                </c:pt>
                <c:pt idx="3">
                  <c:v>0.98733333333333329</c:v>
                </c:pt>
                <c:pt idx="4">
                  <c:v>1.2850000000000001</c:v>
                </c:pt>
                <c:pt idx="5">
                  <c:v>0.7554999999999999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C4B-654E-9EC4-094CF81F092F}"/>
            </c:ext>
          </c:extLst>
        </c:ser>
        <c:ser>
          <c:idx val="2"/>
          <c:order val="2"/>
          <c:tx>
            <c:strRef>
              <c:f>'Mil-conc dep'!$B$5</c:f>
              <c:strCache>
                <c:ptCount val="1"/>
                <c:pt idx="0">
                  <c:v>0.625µM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il-conc dep'!$J$5:$O$5</c:f>
                <c:numCache>
                  <c:formatCode>General</c:formatCode>
                  <c:ptCount val="6"/>
                  <c:pt idx="0">
                    <c:v>5.3313537993020875E-2</c:v>
                  </c:pt>
                  <c:pt idx="1">
                    <c:v>8.1461647417656199E-2</c:v>
                  </c:pt>
                  <c:pt idx="2">
                    <c:v>0.14424978336205471</c:v>
                  </c:pt>
                  <c:pt idx="3">
                    <c:v>7.3627440536797664E-2</c:v>
                  </c:pt>
                  <c:pt idx="4">
                    <c:v>6.3639610306788549E-3</c:v>
                  </c:pt>
                  <c:pt idx="5">
                    <c:v>9.7580735803745988E-2</c:v>
                  </c:pt>
                </c:numCache>
              </c:numRef>
            </c:plus>
            <c:minus>
              <c:numRef>
                <c:f>'Mil-conc dep'!$J$5:$O$5</c:f>
                <c:numCache>
                  <c:formatCode>General</c:formatCode>
                  <c:ptCount val="6"/>
                  <c:pt idx="0">
                    <c:v>5.3313537993020875E-2</c:v>
                  </c:pt>
                  <c:pt idx="1">
                    <c:v>8.1461647417656199E-2</c:v>
                  </c:pt>
                  <c:pt idx="2">
                    <c:v>0.14424978336205471</c:v>
                  </c:pt>
                  <c:pt idx="3">
                    <c:v>7.3627440536797664E-2</c:v>
                  </c:pt>
                  <c:pt idx="4">
                    <c:v>6.3639610306788549E-3</c:v>
                  </c:pt>
                  <c:pt idx="5">
                    <c:v>9.758073580374598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il-conc dep'!$C$2:$H$2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Mil-conc dep'!$C$5:$H$5</c:f>
              <c:numCache>
                <c:formatCode>0.000</c:formatCode>
                <c:ptCount val="6"/>
                <c:pt idx="0">
                  <c:v>0.57566666666666666</c:v>
                </c:pt>
                <c:pt idx="1">
                  <c:v>1.4120000000000001</c:v>
                </c:pt>
                <c:pt idx="2">
                  <c:v>1.508</c:v>
                </c:pt>
                <c:pt idx="3">
                  <c:v>1.038</c:v>
                </c:pt>
                <c:pt idx="4">
                  <c:v>2.2095000000000002</c:v>
                </c:pt>
                <c:pt idx="5">
                  <c:v>1.488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7C4B-654E-9EC4-094CF81F092F}"/>
            </c:ext>
          </c:extLst>
        </c:ser>
        <c:ser>
          <c:idx val="3"/>
          <c:order val="3"/>
          <c:tx>
            <c:strRef>
              <c:f>'Mil-conc dep'!$B$6</c:f>
              <c:strCache>
                <c:ptCount val="1"/>
                <c:pt idx="0">
                  <c:v>1.25µM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il-conc dep'!$J$6:$O$6</c:f>
                <c:numCache>
                  <c:formatCode>General</c:formatCode>
                  <c:ptCount val="6"/>
                  <c:pt idx="0">
                    <c:v>1.778576209593875E-2</c:v>
                  </c:pt>
                  <c:pt idx="1">
                    <c:v>9.948534230394436E-2</c:v>
                  </c:pt>
                  <c:pt idx="2">
                    <c:v>4.8497422611925342E-2</c:v>
                  </c:pt>
                  <c:pt idx="3">
                    <c:v>2.1385353243127212E-2</c:v>
                  </c:pt>
                  <c:pt idx="4">
                    <c:v>2.3094010767585054E-3</c:v>
                  </c:pt>
                  <c:pt idx="5">
                    <c:v>2.8991378028648554E-2</c:v>
                  </c:pt>
                </c:numCache>
              </c:numRef>
            </c:plus>
            <c:minus>
              <c:numRef>
                <c:f>'Mil-conc dep'!$J$6:$O$6</c:f>
                <c:numCache>
                  <c:formatCode>General</c:formatCode>
                  <c:ptCount val="6"/>
                  <c:pt idx="0">
                    <c:v>1.778576209593875E-2</c:v>
                  </c:pt>
                  <c:pt idx="1">
                    <c:v>9.948534230394436E-2</c:v>
                  </c:pt>
                  <c:pt idx="2">
                    <c:v>4.8497422611925342E-2</c:v>
                  </c:pt>
                  <c:pt idx="3">
                    <c:v>2.1385353243127212E-2</c:v>
                  </c:pt>
                  <c:pt idx="4">
                    <c:v>2.3094010767585054E-3</c:v>
                  </c:pt>
                  <c:pt idx="5">
                    <c:v>2.899137802864855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il-conc dep'!$C$2:$H$2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Mil-conc dep'!$C$6:$H$6</c:f>
              <c:numCache>
                <c:formatCode>0.000</c:formatCode>
                <c:ptCount val="6"/>
                <c:pt idx="0">
                  <c:v>0.55266666666666664</c:v>
                </c:pt>
                <c:pt idx="1">
                  <c:v>1.2873333333333334</c:v>
                </c:pt>
                <c:pt idx="2">
                  <c:v>1.57</c:v>
                </c:pt>
                <c:pt idx="3">
                  <c:v>0.94166666666666676</c:v>
                </c:pt>
                <c:pt idx="4">
                  <c:v>1.3126666666666666</c:v>
                </c:pt>
                <c:pt idx="5">
                  <c:v>1.6764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7C4B-654E-9EC4-094CF81F092F}"/>
            </c:ext>
          </c:extLst>
        </c:ser>
        <c:ser>
          <c:idx val="4"/>
          <c:order val="4"/>
          <c:tx>
            <c:strRef>
              <c:f>'Mil-conc dep'!$B$7</c:f>
              <c:strCache>
                <c:ptCount val="1"/>
                <c:pt idx="0">
                  <c:v>2.5µM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il-conc dep'!$J$7:$O$7</c:f>
                <c:numCache>
                  <c:formatCode>General</c:formatCode>
                  <c:ptCount val="6"/>
                  <c:pt idx="0">
                    <c:v>2.0816659994661348E-3</c:v>
                  </c:pt>
                  <c:pt idx="1">
                    <c:v>7.0436732841139355E-2</c:v>
                  </c:pt>
                  <c:pt idx="2">
                    <c:v>5.6011903496788494E-2</c:v>
                  </c:pt>
                  <c:pt idx="3">
                    <c:v>2.8053520278211046E-2</c:v>
                  </c:pt>
                  <c:pt idx="4">
                    <c:v>9.6140522153766048E-2</c:v>
                  </c:pt>
                  <c:pt idx="5">
                    <c:v>3.5355339059328192E-3</c:v>
                  </c:pt>
                </c:numCache>
              </c:numRef>
            </c:plus>
            <c:minus>
              <c:numRef>
                <c:f>'Mil-conc dep'!$J$7:$O$7</c:f>
                <c:numCache>
                  <c:formatCode>General</c:formatCode>
                  <c:ptCount val="6"/>
                  <c:pt idx="0">
                    <c:v>2.0816659994661348E-3</c:v>
                  </c:pt>
                  <c:pt idx="1">
                    <c:v>7.0436732841139355E-2</c:v>
                  </c:pt>
                  <c:pt idx="2">
                    <c:v>5.6011903496788494E-2</c:v>
                  </c:pt>
                  <c:pt idx="3">
                    <c:v>2.8053520278211046E-2</c:v>
                  </c:pt>
                  <c:pt idx="4">
                    <c:v>9.6140522153766048E-2</c:v>
                  </c:pt>
                  <c:pt idx="5">
                    <c:v>3.5355339059328192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il-conc dep'!$C$2:$H$2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Mil-conc dep'!$C$7:$H$7</c:f>
              <c:numCache>
                <c:formatCode>0.000</c:formatCode>
                <c:ptCount val="6"/>
                <c:pt idx="0">
                  <c:v>0.46433333333333332</c:v>
                </c:pt>
                <c:pt idx="1">
                  <c:v>1.2853333333333332</c:v>
                </c:pt>
                <c:pt idx="2">
                  <c:v>1.5806666666666667</c:v>
                </c:pt>
                <c:pt idx="3">
                  <c:v>0.92300000000000004</c:v>
                </c:pt>
                <c:pt idx="4">
                  <c:v>2.0670000000000002</c:v>
                </c:pt>
                <c:pt idx="5">
                  <c:v>1.1505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7C4B-654E-9EC4-094CF81F092F}"/>
            </c:ext>
          </c:extLst>
        </c:ser>
        <c:ser>
          <c:idx val="5"/>
          <c:order val="5"/>
          <c:tx>
            <c:strRef>
              <c:f>'Mil-conc dep'!$B$8</c:f>
              <c:strCache>
                <c:ptCount val="1"/>
                <c:pt idx="0">
                  <c:v>5µM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Mil-conc dep'!$C$2:$H$2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Mil-conc dep'!$C$8:$H$8</c:f>
              <c:numCache>
                <c:formatCode>0.000</c:formatCode>
                <c:ptCount val="6"/>
                <c:pt idx="0">
                  <c:v>0.44933333333333336</c:v>
                </c:pt>
                <c:pt idx="1">
                  <c:v>1.0699999999999998</c:v>
                </c:pt>
                <c:pt idx="2">
                  <c:v>1.3346666666666669</c:v>
                </c:pt>
                <c:pt idx="3">
                  <c:v>0.86066666666666658</c:v>
                </c:pt>
                <c:pt idx="4">
                  <c:v>1.2206666666666666</c:v>
                </c:pt>
                <c:pt idx="5">
                  <c:v>0.675000000000000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7C4B-654E-9EC4-094CF81F092F}"/>
            </c:ext>
          </c:extLst>
        </c:ser>
        <c:ser>
          <c:idx val="6"/>
          <c:order val="6"/>
          <c:tx>
            <c:strRef>
              <c:f>'Mil-conc dep'!$B$9</c:f>
              <c:strCache>
                <c:ptCount val="1"/>
                <c:pt idx="0">
                  <c:v>10µM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il-conc dep'!$J$9:$O$9</c:f>
                <c:numCache>
                  <c:formatCode>General</c:formatCode>
                  <c:ptCount val="6"/>
                  <c:pt idx="0">
                    <c:v>1.9672315572906138E-2</c:v>
                  </c:pt>
                  <c:pt idx="1">
                    <c:v>1.9798989873223347E-2</c:v>
                  </c:pt>
                  <c:pt idx="2">
                    <c:v>5.6568542494920687E-2</c:v>
                  </c:pt>
                  <c:pt idx="3">
                    <c:v>4.5654499595693003E-2</c:v>
                  </c:pt>
                  <c:pt idx="4">
                    <c:v>1.670329308849014E-2</c:v>
                  </c:pt>
                  <c:pt idx="5">
                    <c:v>3.3234018715765354E-2</c:v>
                  </c:pt>
                </c:numCache>
              </c:numRef>
            </c:plus>
            <c:minus>
              <c:numRef>
                <c:f>'Mil-conc dep'!$J$9:$O$9</c:f>
                <c:numCache>
                  <c:formatCode>General</c:formatCode>
                  <c:ptCount val="6"/>
                  <c:pt idx="0">
                    <c:v>1.9672315572906138E-2</c:v>
                  </c:pt>
                  <c:pt idx="1">
                    <c:v>1.9798989873223347E-2</c:v>
                  </c:pt>
                  <c:pt idx="2">
                    <c:v>5.6568542494920687E-2</c:v>
                  </c:pt>
                  <c:pt idx="3">
                    <c:v>4.5654499595693003E-2</c:v>
                  </c:pt>
                  <c:pt idx="4">
                    <c:v>1.670329308849014E-2</c:v>
                  </c:pt>
                  <c:pt idx="5">
                    <c:v>3.323401871576535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il-conc dep'!$C$2:$H$2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Mil-conc dep'!$C$9:$H$9</c:f>
              <c:numCache>
                <c:formatCode>0.000</c:formatCode>
                <c:ptCount val="6"/>
                <c:pt idx="0">
                  <c:v>0.11499999999999999</c:v>
                </c:pt>
                <c:pt idx="1">
                  <c:v>0.77733333333333332</c:v>
                </c:pt>
                <c:pt idx="2">
                  <c:v>1.242</c:v>
                </c:pt>
                <c:pt idx="3">
                  <c:v>0.73066666666666669</c:v>
                </c:pt>
                <c:pt idx="4">
                  <c:v>1.524</c:v>
                </c:pt>
                <c:pt idx="5">
                  <c:v>0.5295000000000000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7C4B-654E-9EC4-094CF81F092F}"/>
            </c:ext>
          </c:extLst>
        </c:ser>
        <c:ser>
          <c:idx val="7"/>
          <c:order val="7"/>
          <c:tx>
            <c:strRef>
              <c:f>'Mil-conc dep'!$B$10</c:f>
              <c:strCache>
                <c:ptCount val="1"/>
                <c:pt idx="0">
                  <c:v>20µM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il-conc dep'!$J$10:$O$10</c:f>
                <c:numCache>
                  <c:formatCode>General</c:formatCode>
                  <c:ptCount val="6"/>
                  <c:pt idx="0">
                    <c:v>1.2701705922171744E-2</c:v>
                  </c:pt>
                  <c:pt idx="1">
                    <c:v>8.085377748338908E-2</c:v>
                  </c:pt>
                  <c:pt idx="2">
                    <c:v>3.3941125496954314E-2</c:v>
                  </c:pt>
                  <c:pt idx="3">
                    <c:v>3.8734136537858135E-2</c:v>
                  </c:pt>
                  <c:pt idx="4">
                    <c:v>9.9122819437974782E-2</c:v>
                  </c:pt>
                  <c:pt idx="5">
                    <c:v>0.15556349186104046</c:v>
                  </c:pt>
                </c:numCache>
              </c:numRef>
            </c:plus>
            <c:minus>
              <c:numRef>
                <c:f>'Mil-conc dep'!$J$10:$O$10</c:f>
                <c:numCache>
                  <c:formatCode>General</c:formatCode>
                  <c:ptCount val="6"/>
                  <c:pt idx="0">
                    <c:v>1.2701705922171744E-2</c:v>
                  </c:pt>
                  <c:pt idx="1">
                    <c:v>8.085377748338908E-2</c:v>
                  </c:pt>
                  <c:pt idx="2">
                    <c:v>3.3941125496954314E-2</c:v>
                  </c:pt>
                  <c:pt idx="3">
                    <c:v>3.8734136537858135E-2</c:v>
                  </c:pt>
                  <c:pt idx="4">
                    <c:v>9.9122819437974782E-2</c:v>
                  </c:pt>
                  <c:pt idx="5">
                    <c:v>0.155563491861040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il-conc dep'!$C$2:$H$2</c:f>
              <c:numCache>
                <c:formatCode>General</c:formatCode>
                <c:ptCount val="6"/>
                <c:pt idx="0">
                  <c:v>4</c:v>
                </c:pt>
                <c:pt idx="1">
                  <c:v>8</c:v>
                </c:pt>
                <c:pt idx="2">
                  <c:v>12</c:v>
                </c:pt>
                <c:pt idx="3">
                  <c:v>18</c:v>
                </c:pt>
                <c:pt idx="4">
                  <c:v>24</c:v>
                </c:pt>
                <c:pt idx="5">
                  <c:v>48</c:v>
                </c:pt>
              </c:numCache>
            </c:numRef>
          </c:xVal>
          <c:yVal>
            <c:numRef>
              <c:f>'Mil-conc dep'!$C$10:$H$10</c:f>
              <c:numCache>
                <c:formatCode>0.000</c:formatCode>
                <c:ptCount val="6"/>
                <c:pt idx="0">
                  <c:v>9.1666666666666674E-2</c:v>
                </c:pt>
                <c:pt idx="1">
                  <c:v>0.53866666666666663</c:v>
                </c:pt>
                <c:pt idx="2">
                  <c:v>1.3140000000000001</c:v>
                </c:pt>
                <c:pt idx="3">
                  <c:v>0.64066666666666661</c:v>
                </c:pt>
                <c:pt idx="4">
                  <c:v>0.99333333333333329</c:v>
                </c:pt>
                <c:pt idx="5">
                  <c:v>0.637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7C4B-654E-9EC4-094CF81F09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44566736"/>
        <c:axId val="1744568384"/>
      </c:scatterChart>
      <c:valAx>
        <c:axId val="17445667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200" b="1" i="0" baseline="0">
                    <a:effectLst/>
                  </a:rPr>
                  <a:t>Time (hs)</a:t>
                </a:r>
                <a:endParaRPr lang="en-NG" sz="120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44568384"/>
        <c:crosses val="autoZero"/>
        <c:crossBetween val="midCat"/>
      </c:valAx>
      <c:valAx>
        <c:axId val="1744568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sz="1200" b="1" i="0" baseline="0">
                    <a:effectLst/>
                  </a:rPr>
                  <a:t>Absorbance of eluted crystal violet at 570nm (biofilms) </a:t>
                </a:r>
                <a:endParaRPr lang="en-NG" sz="1200">
                  <a:effectLst/>
                </a:endParaRPr>
              </a:p>
            </c:rich>
          </c:tx>
          <c:layout>
            <c:manualLayout>
              <c:xMode val="edge"/>
              <c:yMode val="edge"/>
              <c:x val="4.4466188050023156E-2"/>
              <c:y val="0.135872960014076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4456673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4197079099552385"/>
          <c:y val="0.10110544142875995"/>
          <c:w val="0.15630738066455385"/>
          <c:h val="0.3877213742136981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0861</cdr:x>
      <cdr:y>0</cdr:y>
    </cdr:from>
    <cdr:to>
      <cdr:x>0.0509</cdr:x>
      <cdr:y>0.06425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17A072B9-4B95-E5BD-B588-19A4C58BD2D9}"/>
            </a:ext>
          </a:extLst>
        </cdr:cNvPr>
        <cdr:cNvSpPr txBox="1"/>
      </cdr:nvSpPr>
      <cdr:spPr>
        <a:xfrm xmlns:a="http://schemas.openxmlformats.org/drawingml/2006/main">
          <a:off x="50880" y="-22302"/>
          <a:ext cx="249907" cy="2364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1962</cdr:x>
      <cdr:y>0.01723</cdr:y>
    </cdr:from>
    <cdr:to>
      <cdr:x>0.06154</cdr:x>
      <cdr:y>0.0814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4615BC3F-716D-65C2-E6A0-09701732DCFD}"/>
            </a:ext>
          </a:extLst>
        </cdr:cNvPr>
        <cdr:cNvSpPr txBox="1"/>
      </cdr:nvSpPr>
      <cdr:spPr>
        <a:xfrm xmlns:a="http://schemas.openxmlformats.org/drawingml/2006/main">
          <a:off x="116905" y="63407"/>
          <a:ext cx="249816" cy="2364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3465</cdr:x>
      <cdr:y>0.01117</cdr:y>
    </cdr:from>
    <cdr:to>
      <cdr:x>0.07667</cdr:x>
      <cdr:y>0.0754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4615BC3F-716D-65C2-E6A0-09701732DCFD}"/>
            </a:ext>
          </a:extLst>
        </cdr:cNvPr>
        <cdr:cNvSpPr txBox="1"/>
      </cdr:nvSpPr>
      <cdr:spPr>
        <a:xfrm xmlns:a="http://schemas.openxmlformats.org/drawingml/2006/main">
          <a:off x="206068" y="41105"/>
          <a:ext cx="249887" cy="2364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2E7258-8190-CA4F-99F5-208AC5479CC0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6338" y="1143000"/>
            <a:ext cx="19653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x-non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270DFF-B72F-8F45-9FDD-6E5F17D3F315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537652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995312"/>
            <a:ext cx="6606540" cy="4244622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6403623"/>
            <a:ext cx="5829300" cy="2943577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503659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323580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649111"/>
            <a:ext cx="1675924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649111"/>
            <a:ext cx="4930616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421822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625039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3039537"/>
            <a:ext cx="6703695" cy="5071532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8159048"/>
            <a:ext cx="6703695" cy="2666999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798078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3245556"/>
            <a:ext cx="330327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3245556"/>
            <a:ext cx="330327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998149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49114"/>
            <a:ext cx="670369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988734"/>
            <a:ext cx="3288089" cy="1464732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4453467"/>
            <a:ext cx="328808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988734"/>
            <a:ext cx="3304282" cy="1464732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4453467"/>
            <a:ext cx="3304282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642544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609208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54482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812800"/>
            <a:ext cx="2506801" cy="28448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755425"/>
            <a:ext cx="3934778" cy="8664222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657600"/>
            <a:ext cx="2506801" cy="6776156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361902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812800"/>
            <a:ext cx="2506801" cy="28448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755425"/>
            <a:ext cx="3934778" cy="8664222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657600"/>
            <a:ext cx="2506801" cy="6776156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76077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649114"/>
            <a:ext cx="670369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3245556"/>
            <a:ext cx="670369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11300181"/>
            <a:ext cx="174879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5994BE-D80C-2145-9739-1872945E2134}" type="datetimeFigureOut">
              <a:rPr lang="x-none" smtClean="0"/>
              <a:t>6/22/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11300181"/>
            <a:ext cx="262318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11300181"/>
            <a:ext cx="174879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B7F0F-2437-B941-BBB7-B111A35B80C8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372651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2C4E9D1C-7FF0-6142-85CB-A054E718E3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7895173"/>
              </p:ext>
            </p:extLst>
          </p:nvPr>
        </p:nvGraphicFramePr>
        <p:xfrm>
          <a:off x="557561" y="472069"/>
          <a:ext cx="5909379" cy="36799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AB1AB61C-CD2C-F54C-9755-12E7A4E49D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49105"/>
              </p:ext>
            </p:extLst>
          </p:nvPr>
        </p:nvGraphicFramePr>
        <p:xfrm>
          <a:off x="507587" y="4074222"/>
          <a:ext cx="5959353" cy="36799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9A104F08-A3BF-8949-B8B1-490F841F76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77929095"/>
              </p:ext>
            </p:extLst>
          </p:nvPr>
        </p:nvGraphicFramePr>
        <p:xfrm>
          <a:off x="498546" y="8053039"/>
          <a:ext cx="5946859" cy="36799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327518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0</TotalTime>
  <Words>45</Words>
  <Application>Microsoft Macintosh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Kwasi</dc:creator>
  <cp:lastModifiedBy>Iruka Okeke</cp:lastModifiedBy>
  <cp:revision>25</cp:revision>
  <dcterms:created xsi:type="dcterms:W3CDTF">2022-04-04T11:57:21Z</dcterms:created>
  <dcterms:modified xsi:type="dcterms:W3CDTF">2022-06-22T07:34:26Z</dcterms:modified>
</cp:coreProperties>
</file>